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4"/>
  </p:notesMasterIdLst>
  <p:sldIdLst>
    <p:sldId id="309" r:id="rId2"/>
    <p:sldId id="319" r:id="rId3"/>
  </p:sldIdLst>
  <p:sldSz cx="7772400" cy="10058400"/>
  <p:notesSz cx="7315200" cy="96012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egura, Jason (NIH/NIAID) [F]" initials="SJ([" lastIdx="1" clrIdx="0">
    <p:extLst>
      <p:ext uri="{19B8F6BF-5375-455C-9EA6-DF929625EA0E}">
        <p15:presenceInfo xmlns:p15="http://schemas.microsoft.com/office/powerpoint/2012/main" userId="S::segurajm@nih.gov::9b1b00a5-cc17-4204-89f3-061b6febed78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A01BF"/>
    <a:srgbClr val="03E2E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062" autoAdjust="0"/>
    <p:restoredTop sz="96357" autoAdjust="0"/>
  </p:normalViewPr>
  <p:slideViewPr>
    <p:cSldViewPr snapToGrid="0">
      <p:cViewPr varScale="1">
        <p:scale>
          <a:sx n="78" d="100"/>
          <a:sy n="78" d="100"/>
        </p:scale>
        <p:origin x="305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70475" cy="481045"/>
          </a:xfrm>
          <a:prstGeom prst="rect">
            <a:avLst/>
          </a:prstGeom>
        </p:spPr>
        <p:txBody>
          <a:bodyPr vert="horz" lIns="95069" tIns="47534" rIns="95069" bIns="47534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064" y="0"/>
            <a:ext cx="3170475" cy="481045"/>
          </a:xfrm>
          <a:prstGeom prst="rect">
            <a:avLst/>
          </a:prstGeom>
        </p:spPr>
        <p:txBody>
          <a:bodyPr vert="horz" lIns="95069" tIns="47534" rIns="95069" bIns="47534" rtlCol="0"/>
          <a:lstStyle>
            <a:lvl1pPr algn="r">
              <a:defRPr sz="1200"/>
            </a:lvl1pPr>
          </a:lstStyle>
          <a:p>
            <a:fld id="{AC15AEC4-8305-46B6-B820-9070F90C275D}" type="datetimeFigureOut">
              <a:rPr lang="en-US" smtClean="0"/>
              <a:t>1/20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05063" y="1200150"/>
            <a:ext cx="2505075" cy="32416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5069" tIns="47534" rIns="95069" bIns="47534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620004"/>
            <a:ext cx="5852160" cy="3781047"/>
          </a:xfrm>
          <a:prstGeom prst="rect">
            <a:avLst/>
          </a:prstGeom>
        </p:spPr>
        <p:txBody>
          <a:bodyPr vert="horz" lIns="95069" tIns="47534" rIns="95069" bIns="47534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20156"/>
            <a:ext cx="3170475" cy="481044"/>
          </a:xfrm>
          <a:prstGeom prst="rect">
            <a:avLst/>
          </a:prstGeom>
        </p:spPr>
        <p:txBody>
          <a:bodyPr vert="horz" lIns="95069" tIns="47534" rIns="95069" bIns="47534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064" y="9120156"/>
            <a:ext cx="3170475" cy="481044"/>
          </a:xfrm>
          <a:prstGeom prst="rect">
            <a:avLst/>
          </a:prstGeom>
        </p:spPr>
        <p:txBody>
          <a:bodyPr vert="horz" lIns="95069" tIns="47534" rIns="95069" bIns="47534" rtlCol="0" anchor="b"/>
          <a:lstStyle>
            <a:lvl1pPr algn="r">
              <a:defRPr sz="1200"/>
            </a:lvl1pPr>
          </a:lstStyle>
          <a:p>
            <a:fld id="{06BD53CA-9DAD-47B5-89E1-B7E105B0A6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88622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95F23-18C9-4FDD-B977-A9478D2B8669}" type="datetimeFigureOut">
              <a:rPr lang="en-US" smtClean="0"/>
              <a:t>1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3FA91-113B-4BC5-8528-47FE1A2039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69420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95F23-18C9-4FDD-B977-A9478D2B8669}" type="datetimeFigureOut">
              <a:rPr lang="en-US" smtClean="0"/>
              <a:t>1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3FA91-113B-4BC5-8528-47FE1A2039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4210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95F23-18C9-4FDD-B977-A9478D2B8669}" type="datetimeFigureOut">
              <a:rPr lang="en-US" smtClean="0"/>
              <a:t>1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3FA91-113B-4BC5-8528-47FE1A2039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01867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95F23-18C9-4FDD-B977-A9478D2B8669}" type="datetimeFigureOut">
              <a:rPr lang="en-US" smtClean="0"/>
              <a:t>1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3FA91-113B-4BC5-8528-47FE1A2039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29734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95F23-18C9-4FDD-B977-A9478D2B8669}" type="datetimeFigureOut">
              <a:rPr lang="en-US" smtClean="0"/>
              <a:t>1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3FA91-113B-4BC5-8528-47FE1A2039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35204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95F23-18C9-4FDD-B977-A9478D2B8669}" type="datetimeFigureOut">
              <a:rPr lang="en-US" smtClean="0"/>
              <a:t>1/2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3FA91-113B-4BC5-8528-47FE1A2039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15075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95F23-18C9-4FDD-B977-A9478D2B8669}" type="datetimeFigureOut">
              <a:rPr lang="en-US" smtClean="0"/>
              <a:t>1/20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3FA91-113B-4BC5-8528-47FE1A2039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9765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95F23-18C9-4FDD-B977-A9478D2B8669}" type="datetimeFigureOut">
              <a:rPr lang="en-US" smtClean="0"/>
              <a:t>1/20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3FA91-113B-4BC5-8528-47FE1A2039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38677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95F23-18C9-4FDD-B977-A9478D2B8669}" type="datetimeFigureOut">
              <a:rPr lang="en-US" smtClean="0"/>
              <a:t>1/20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3FA91-113B-4BC5-8528-47FE1A2039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68576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95F23-18C9-4FDD-B977-A9478D2B8669}" type="datetimeFigureOut">
              <a:rPr lang="en-US" smtClean="0"/>
              <a:t>1/2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3FA91-113B-4BC5-8528-47FE1A2039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26855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95F23-18C9-4FDD-B977-A9478D2B8669}" type="datetimeFigureOut">
              <a:rPr lang="en-US" smtClean="0"/>
              <a:t>1/2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3FA91-113B-4BC5-8528-47FE1A2039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86051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B95F23-18C9-4FDD-B977-A9478D2B8669}" type="datetimeFigureOut">
              <a:rPr lang="en-US" smtClean="0"/>
              <a:t>1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73FA91-113B-4BC5-8528-47FE1A2039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82495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TextBox 50">
            <a:extLst>
              <a:ext uri="{FF2B5EF4-FFF2-40B4-BE49-F238E27FC236}">
                <a16:creationId xmlns:a16="http://schemas.microsoft.com/office/drawing/2014/main" id="{62AA2D5C-75DC-4AA9-9270-FFE6D7812C0B}"/>
              </a:ext>
            </a:extLst>
          </p:cNvPr>
          <p:cNvSpPr txBox="1"/>
          <p:nvPr/>
        </p:nvSpPr>
        <p:spPr>
          <a:xfrm>
            <a:off x="6225589" y="4781839"/>
            <a:ext cx="145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aphicFrame>
        <p:nvGraphicFramePr>
          <p:cNvPr id="52" name="Table 51">
            <a:extLst>
              <a:ext uri="{FF2B5EF4-FFF2-40B4-BE49-F238E27FC236}">
                <a16:creationId xmlns:a16="http://schemas.microsoft.com/office/drawing/2014/main" id="{9E40D37D-472D-4BE1-9F78-A765DE45C04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51846458"/>
              </p:ext>
            </p:extLst>
          </p:nvPr>
        </p:nvGraphicFramePr>
        <p:xfrm>
          <a:off x="3611195" y="591985"/>
          <a:ext cx="312906" cy="1863092"/>
        </p:xfrm>
        <a:graphic>
          <a:graphicData uri="http://schemas.openxmlformats.org/drawingml/2006/table">
            <a:tbl>
              <a:tblPr/>
              <a:tblGrid>
                <a:gridCol w="312906">
                  <a:extLst>
                    <a:ext uri="{9D8B030D-6E8A-4147-A177-3AD203B41FA5}">
                      <a16:colId xmlns:a16="http://schemas.microsoft.com/office/drawing/2014/main" val="1884288143"/>
                    </a:ext>
                  </a:extLst>
                </a:gridCol>
              </a:tblGrid>
              <a:tr h="266156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7102267"/>
                  </a:ext>
                </a:extLst>
              </a:tr>
              <a:tr h="266156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2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808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17510517"/>
                  </a:ext>
                </a:extLst>
              </a:tr>
              <a:tr h="266156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12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C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39716007"/>
                  </a:ext>
                </a:extLst>
              </a:tr>
              <a:tr h="266156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96836605"/>
                  </a:ext>
                </a:extLst>
              </a:tr>
              <a:tr h="266156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.12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FB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82131775"/>
                  </a:ext>
                </a:extLst>
              </a:tr>
              <a:tr h="266156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.2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7F7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37959204"/>
                  </a:ext>
                </a:extLst>
              </a:tr>
              <a:tr h="266156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.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00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07315902"/>
                  </a:ext>
                </a:extLst>
              </a:tr>
            </a:tbl>
          </a:graphicData>
        </a:graphic>
      </p:graphicFrame>
      <p:graphicFrame>
        <p:nvGraphicFramePr>
          <p:cNvPr id="58" name="Table 57">
            <a:extLst>
              <a:ext uri="{FF2B5EF4-FFF2-40B4-BE49-F238E27FC236}">
                <a16:creationId xmlns:a16="http://schemas.microsoft.com/office/drawing/2014/main" id="{4B76A214-2CC7-4B72-BBFC-554B42EEC6B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58792473"/>
              </p:ext>
            </p:extLst>
          </p:nvPr>
        </p:nvGraphicFramePr>
        <p:xfrm>
          <a:off x="754386" y="591985"/>
          <a:ext cx="2601280" cy="2966085"/>
        </p:xfrm>
        <a:graphic>
          <a:graphicData uri="http://schemas.openxmlformats.org/drawingml/2006/table">
            <a:tbl>
              <a:tblPr/>
              <a:tblGrid>
                <a:gridCol w="175819">
                  <a:extLst>
                    <a:ext uri="{9D8B030D-6E8A-4147-A177-3AD203B41FA5}">
                      <a16:colId xmlns:a16="http://schemas.microsoft.com/office/drawing/2014/main" val="1567633938"/>
                    </a:ext>
                  </a:extLst>
                </a:gridCol>
                <a:gridCol w="146757">
                  <a:extLst>
                    <a:ext uri="{9D8B030D-6E8A-4147-A177-3AD203B41FA5}">
                      <a16:colId xmlns:a16="http://schemas.microsoft.com/office/drawing/2014/main" val="4200254721"/>
                    </a:ext>
                  </a:extLst>
                </a:gridCol>
                <a:gridCol w="322287">
                  <a:extLst>
                    <a:ext uri="{9D8B030D-6E8A-4147-A177-3AD203B41FA5}">
                      <a16:colId xmlns:a16="http://schemas.microsoft.com/office/drawing/2014/main" val="966098401"/>
                    </a:ext>
                  </a:extLst>
                </a:gridCol>
                <a:gridCol w="326910">
                  <a:extLst>
                    <a:ext uri="{9D8B030D-6E8A-4147-A177-3AD203B41FA5}">
                      <a16:colId xmlns:a16="http://schemas.microsoft.com/office/drawing/2014/main" val="1320180166"/>
                    </a:ext>
                  </a:extLst>
                </a:gridCol>
                <a:gridCol w="326910">
                  <a:extLst>
                    <a:ext uri="{9D8B030D-6E8A-4147-A177-3AD203B41FA5}">
                      <a16:colId xmlns:a16="http://schemas.microsoft.com/office/drawing/2014/main" val="2988595435"/>
                    </a:ext>
                  </a:extLst>
                </a:gridCol>
                <a:gridCol w="326910">
                  <a:extLst>
                    <a:ext uri="{9D8B030D-6E8A-4147-A177-3AD203B41FA5}">
                      <a16:colId xmlns:a16="http://schemas.microsoft.com/office/drawing/2014/main" val="3864626974"/>
                    </a:ext>
                  </a:extLst>
                </a:gridCol>
                <a:gridCol w="326910">
                  <a:extLst>
                    <a:ext uri="{9D8B030D-6E8A-4147-A177-3AD203B41FA5}">
                      <a16:colId xmlns:a16="http://schemas.microsoft.com/office/drawing/2014/main" val="2551070926"/>
                    </a:ext>
                  </a:extLst>
                </a:gridCol>
                <a:gridCol w="317434">
                  <a:extLst>
                    <a:ext uri="{9D8B030D-6E8A-4147-A177-3AD203B41FA5}">
                      <a16:colId xmlns:a16="http://schemas.microsoft.com/office/drawing/2014/main" val="3556224560"/>
                    </a:ext>
                  </a:extLst>
                </a:gridCol>
                <a:gridCol w="331343">
                  <a:extLst>
                    <a:ext uri="{9D8B030D-6E8A-4147-A177-3AD203B41FA5}">
                      <a16:colId xmlns:a16="http://schemas.microsoft.com/office/drawing/2014/main" val="339455365"/>
                    </a:ext>
                  </a:extLst>
                </a:gridCol>
              </a:tblGrid>
              <a:tr h="150613">
                <a:tc gridSpan="2"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V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I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4932915"/>
                  </a:ext>
                </a:extLst>
              </a:tr>
              <a:tr h="116790"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25754142"/>
                  </a:ext>
                </a:extLst>
              </a:tr>
              <a:tr h="150613">
                <a:tc rowSpan="15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RFERON-INDUCIBLE</a:t>
                      </a:r>
                    </a:p>
                  </a:txBody>
                  <a:tcPr marL="9525" marR="9525" marT="9525" marB="0" vert="vert27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FI16               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FI16              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E5E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A9A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8E8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4E4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8A8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44192605"/>
                  </a:ext>
                </a:extLst>
              </a:tr>
              <a:tr h="15061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FI27L1             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FI27L1            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FD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363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C6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EDE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46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68767253"/>
                  </a:ext>
                </a:extLst>
              </a:tr>
              <a:tr h="15061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FI27L2             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FI27L2            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595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757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E4E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69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85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4F4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95171078"/>
                  </a:ext>
                </a:extLst>
              </a:tr>
              <a:tr h="15061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FI35               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FI35              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7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A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282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666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BE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727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89876952"/>
                  </a:ext>
                </a:extLst>
              </a:tr>
              <a:tr h="15061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FI44               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FI44              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87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777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7063795"/>
                  </a:ext>
                </a:extLst>
              </a:tr>
              <a:tr h="15061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FI44L              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FI44L             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13530845"/>
                  </a:ext>
                </a:extLst>
              </a:tr>
              <a:tr h="15061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FI6                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FI6               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A0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BCB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909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68522183"/>
                  </a:ext>
                </a:extLst>
              </a:tr>
              <a:tr h="15061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FIH1               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FIH1              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494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26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848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161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76263324"/>
                  </a:ext>
                </a:extLst>
              </a:tr>
              <a:tr h="15061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FIT1               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FIT1              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F7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E7E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89218921"/>
                  </a:ext>
                </a:extLst>
              </a:tr>
              <a:tr h="15061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FIT2               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FIT2              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888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787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79421744"/>
                  </a:ext>
                </a:extLst>
              </a:tr>
              <a:tr h="15061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FIT3               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FIT3              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51492834"/>
                  </a:ext>
                </a:extLst>
              </a:tr>
              <a:tr h="15061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FIT5               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FIT5              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B0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8C8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A0A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B8B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03041590"/>
                  </a:ext>
                </a:extLst>
              </a:tr>
              <a:tr h="15061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FITM1              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FITM1             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8E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D2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BEB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3D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BD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80756694"/>
                  </a:ext>
                </a:extLst>
              </a:tr>
              <a:tr h="15061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FITM2              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FITM2             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E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C2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BBB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DE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3C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ABA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71368041"/>
                  </a:ext>
                </a:extLst>
              </a:tr>
              <a:tr h="15061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FITM3              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FITM3             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3F3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B8B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5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E3E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7B7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4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06101533"/>
                  </a:ext>
                </a:extLst>
              </a:tr>
            </a:tbl>
          </a:graphicData>
        </a:graphic>
      </p:graphicFrame>
      <p:graphicFrame>
        <p:nvGraphicFramePr>
          <p:cNvPr id="59" name="Table 58">
            <a:extLst>
              <a:ext uri="{FF2B5EF4-FFF2-40B4-BE49-F238E27FC236}">
                <a16:creationId xmlns:a16="http://schemas.microsoft.com/office/drawing/2014/main" id="{AB739E8F-027B-43A5-9D2A-435DF5352FE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2344386"/>
              </p:ext>
            </p:extLst>
          </p:nvPr>
        </p:nvGraphicFramePr>
        <p:xfrm>
          <a:off x="4615782" y="591985"/>
          <a:ext cx="2594048" cy="5896928"/>
        </p:xfrm>
        <a:graphic>
          <a:graphicData uri="http://schemas.openxmlformats.org/drawingml/2006/table">
            <a:tbl>
              <a:tblPr/>
              <a:tblGrid>
                <a:gridCol w="172252">
                  <a:extLst>
                    <a:ext uri="{9D8B030D-6E8A-4147-A177-3AD203B41FA5}">
                      <a16:colId xmlns:a16="http://schemas.microsoft.com/office/drawing/2014/main" val="1811117598"/>
                    </a:ext>
                  </a:extLst>
                </a:gridCol>
                <a:gridCol w="152004">
                  <a:extLst>
                    <a:ext uri="{9D8B030D-6E8A-4147-A177-3AD203B41FA5}">
                      <a16:colId xmlns:a16="http://schemas.microsoft.com/office/drawing/2014/main" val="2583435864"/>
                    </a:ext>
                  </a:extLst>
                </a:gridCol>
                <a:gridCol w="313888">
                  <a:extLst>
                    <a:ext uri="{9D8B030D-6E8A-4147-A177-3AD203B41FA5}">
                      <a16:colId xmlns:a16="http://schemas.microsoft.com/office/drawing/2014/main" val="532198376"/>
                    </a:ext>
                  </a:extLst>
                </a:gridCol>
                <a:gridCol w="330297">
                  <a:extLst>
                    <a:ext uri="{9D8B030D-6E8A-4147-A177-3AD203B41FA5}">
                      <a16:colId xmlns:a16="http://schemas.microsoft.com/office/drawing/2014/main" val="2660697108"/>
                    </a:ext>
                  </a:extLst>
                </a:gridCol>
                <a:gridCol w="323343">
                  <a:extLst>
                    <a:ext uri="{9D8B030D-6E8A-4147-A177-3AD203B41FA5}">
                      <a16:colId xmlns:a16="http://schemas.microsoft.com/office/drawing/2014/main" val="1091066018"/>
                    </a:ext>
                  </a:extLst>
                </a:gridCol>
                <a:gridCol w="329496">
                  <a:extLst>
                    <a:ext uri="{9D8B030D-6E8A-4147-A177-3AD203B41FA5}">
                      <a16:colId xmlns:a16="http://schemas.microsoft.com/office/drawing/2014/main" val="3843849363"/>
                    </a:ext>
                  </a:extLst>
                </a:gridCol>
                <a:gridCol w="324256">
                  <a:extLst>
                    <a:ext uri="{9D8B030D-6E8A-4147-A177-3AD203B41FA5}">
                      <a16:colId xmlns:a16="http://schemas.microsoft.com/office/drawing/2014/main" val="304354703"/>
                    </a:ext>
                  </a:extLst>
                </a:gridCol>
                <a:gridCol w="319753">
                  <a:extLst>
                    <a:ext uri="{9D8B030D-6E8A-4147-A177-3AD203B41FA5}">
                      <a16:colId xmlns:a16="http://schemas.microsoft.com/office/drawing/2014/main" val="493177369"/>
                    </a:ext>
                  </a:extLst>
                </a:gridCol>
                <a:gridCol w="328759">
                  <a:extLst>
                    <a:ext uri="{9D8B030D-6E8A-4147-A177-3AD203B41FA5}">
                      <a16:colId xmlns:a16="http://schemas.microsoft.com/office/drawing/2014/main" val="358693711"/>
                    </a:ext>
                  </a:extLst>
                </a:gridCol>
              </a:tblGrid>
              <a:tr h="113555">
                <a:tc gridSpan="2">
                  <a:txBody>
                    <a:bodyPr/>
                    <a:lstStyle/>
                    <a:p>
                      <a:pPr algn="ctr" fontAlgn="b"/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24" marR="8624" marT="86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624" marR="8624" marT="862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24" marR="8624" marT="8624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V</a:t>
                      </a:r>
                    </a:p>
                  </a:txBody>
                  <a:tcPr marL="8624" marR="8624" marT="86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I</a:t>
                      </a:r>
                    </a:p>
                  </a:txBody>
                  <a:tcPr marL="8624" marR="8624" marT="86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06926591"/>
                  </a:ext>
                </a:extLst>
              </a:tr>
              <a:tr h="113555"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</a:p>
                  </a:txBody>
                  <a:tcPr marL="8624" marR="8624" marT="86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8624" marR="8624" marT="86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8624" marR="8624" marT="86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8624" marR="8624" marT="86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8624" marR="8624" marT="86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8624" marR="8624" marT="86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8624" marR="8624" marT="86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46996491"/>
                  </a:ext>
                </a:extLst>
              </a:tr>
              <a:tr h="140068">
                <a:tc rowSpan="35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M</a:t>
                      </a:r>
                    </a:p>
                  </a:txBody>
                  <a:tcPr marL="8624" marR="8624" marT="8624" marB="0" vert="vert27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M2               </a:t>
                      </a:r>
                    </a:p>
                  </a:txBody>
                  <a:tcPr marL="8624" marR="8624" marT="86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IM2               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717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ADA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7070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DBD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76136257"/>
                  </a:ext>
                </a:extLst>
              </a:tr>
              <a:tr h="140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M3               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24" marR="8624" marT="86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IM3               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BD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1A1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0F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ADA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919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26112444"/>
                  </a:ext>
                </a:extLst>
              </a:tr>
              <a:tr h="140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M4               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24" marR="8624" marT="86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IM4               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4F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5E5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CF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3F3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FB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88092010"/>
                  </a:ext>
                </a:extLst>
              </a:tr>
              <a:tr h="140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M5               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24" marR="8624" marT="86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IM5               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8C8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A5A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97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B8B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4A4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878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26264408"/>
                  </a:ext>
                </a:extLst>
              </a:tr>
              <a:tr h="140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M8               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24" marR="8624" marT="86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IM8               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C8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6F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A9A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8D8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5F5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B9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39702439"/>
                  </a:ext>
                </a:extLst>
              </a:tr>
              <a:tr h="140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M11              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24" marR="8624" marT="86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IM11              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2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F9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BE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1F1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AF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A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46379537"/>
                  </a:ext>
                </a:extLst>
              </a:tr>
              <a:tr h="140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M13              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24" marR="8624" marT="86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IM13              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DE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8E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E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5066348"/>
                  </a:ext>
                </a:extLst>
              </a:tr>
              <a:tr h="140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M14              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24" marR="8624" marT="86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IM14              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39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36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404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92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262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F3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53950246"/>
                  </a:ext>
                </a:extLst>
              </a:tr>
              <a:tr h="140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M16              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24" marR="8624" marT="86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IM16              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4A4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787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A5A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8E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888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23959290"/>
                  </a:ext>
                </a:extLst>
              </a:tr>
              <a:tr h="140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M21              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24" marR="8624" marT="86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IM21              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B4B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4E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484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3B3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3E3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747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30438816"/>
                  </a:ext>
                </a:extLst>
              </a:tr>
              <a:tr h="140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M22              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24" marR="8624" marT="86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IM22              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292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454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1D1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828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444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C1C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2405709"/>
                  </a:ext>
                </a:extLst>
              </a:tr>
              <a:tr h="140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M23              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24" marR="8624" marT="86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IM23              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DD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DC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DCD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CD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E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96679611"/>
                  </a:ext>
                </a:extLst>
              </a:tr>
              <a:tr h="140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M24              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24" marR="8624" marT="86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IM24              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5D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878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DF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4D4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686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82416850"/>
                  </a:ext>
                </a:extLst>
              </a:tr>
              <a:tr h="140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M25              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24" marR="8624" marT="86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IM25              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8B8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59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1C1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A8A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494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B1B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64248503"/>
                  </a:ext>
                </a:extLst>
              </a:tr>
              <a:tr h="140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M26              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24" marR="8624" marT="86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IM26              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BE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5C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6C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A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4C4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5C5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64508522"/>
                  </a:ext>
                </a:extLst>
              </a:tr>
              <a:tr h="140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M27              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24" marR="8624" marT="86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IM27              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FC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6F6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ECE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7F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35530624"/>
                  </a:ext>
                </a:extLst>
              </a:tr>
              <a:tr h="140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M28              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24" marR="8624" marT="86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IM28              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ED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3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4B4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DDD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B5B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74729281"/>
                  </a:ext>
                </a:extLst>
              </a:tr>
              <a:tr h="140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M32              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24" marR="8624" marT="86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IM32              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494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CD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A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59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DD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B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83005528"/>
                  </a:ext>
                </a:extLst>
              </a:tr>
              <a:tr h="140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M33              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24" marR="8624" marT="86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IM33              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0D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D5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BFB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FC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C5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EBE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48861239"/>
                  </a:ext>
                </a:extLst>
              </a:tr>
              <a:tr h="140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M35              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24" marR="8624" marT="86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IM35              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BDB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8C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8C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CB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7C7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7C7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32870833"/>
                  </a:ext>
                </a:extLst>
              </a:tr>
              <a:tr h="140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M37              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24" marR="8624" marT="86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IM37              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FD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ABA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EC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EF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AAA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DCD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71933730"/>
                  </a:ext>
                </a:extLst>
              </a:tr>
              <a:tr h="140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M38              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24" marR="8624" marT="86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IM38              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BC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8A8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A4A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CA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989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3A3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39480176"/>
                  </a:ext>
                </a:extLst>
              </a:tr>
              <a:tr h="140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M39              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24" marR="8624" marT="86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IM39              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FE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FD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EE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0E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DC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9108514"/>
                  </a:ext>
                </a:extLst>
              </a:tr>
              <a:tr h="140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M41              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24" marR="8624" marT="86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IM41              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EF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6D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C0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FD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5D5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1C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56788107"/>
                  </a:ext>
                </a:extLst>
              </a:tr>
              <a:tr h="140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M44              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24" marR="8624" marT="86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IM44              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ABA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313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79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AAA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030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696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44605986"/>
                  </a:ext>
                </a:extLst>
              </a:tr>
              <a:tr h="140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M46              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24" marR="8624" marT="86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IM46              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FD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B4B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8F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EDE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3B3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F7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18070725"/>
                  </a:ext>
                </a:extLst>
              </a:tr>
              <a:tr h="140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M47              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24" marR="8624" marT="86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IM47              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DDD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1D1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4D4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ED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2D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5D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78398042"/>
                  </a:ext>
                </a:extLst>
              </a:tr>
              <a:tr h="140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M52              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24" marR="8624" marT="86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IM52              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A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8C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4D4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9E9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7C7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5D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63308479"/>
                  </a:ext>
                </a:extLst>
              </a:tr>
              <a:tr h="140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M56              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24" marR="8624" marT="86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IM56              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99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3D3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E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898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C3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D6D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77981878"/>
                  </a:ext>
                </a:extLst>
              </a:tr>
              <a:tr h="140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M59              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24" marR="8624" marT="86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IM59              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3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B9B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AD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C9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15800658"/>
                  </a:ext>
                </a:extLst>
              </a:tr>
              <a:tr h="140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M62              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24" marR="8624" marT="86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IM62              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8C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AEA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B7B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7C7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DAD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6B6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4832008"/>
                  </a:ext>
                </a:extLst>
              </a:tr>
              <a:tr h="140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M65              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24" marR="8624" marT="86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IM65              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AC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5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DE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9C9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4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EC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85743377"/>
                  </a:ext>
                </a:extLst>
              </a:tr>
              <a:tr h="140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M66              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24" marR="8624" marT="86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IM66              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6F6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E5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F9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7F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D5D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E9E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47590957"/>
                  </a:ext>
                </a:extLst>
              </a:tr>
              <a:tr h="140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M68              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24" marR="8624" marT="86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IM68              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BDB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4E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F9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CD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3E3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AF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15564155"/>
                  </a:ext>
                </a:extLst>
              </a:tr>
              <a:tr h="140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M69              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24" marR="8624" marT="86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IM69              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7F7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DB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AD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8F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CD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624" marR="8624" marT="86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2166349"/>
                  </a:ext>
                </a:extLst>
              </a:tr>
            </a:tbl>
          </a:graphicData>
        </a:graphic>
      </p:graphicFrame>
      <p:sp>
        <p:nvSpPr>
          <p:cNvPr id="61" name="TextBox 60">
            <a:extLst>
              <a:ext uri="{FF2B5EF4-FFF2-40B4-BE49-F238E27FC236}">
                <a16:creationId xmlns:a16="http://schemas.microsoft.com/office/drawing/2014/main" id="{28502677-BB2C-49AA-BD96-A3DE074AC983}"/>
              </a:ext>
            </a:extLst>
          </p:cNvPr>
          <p:cNvSpPr txBox="1"/>
          <p:nvPr/>
        </p:nvSpPr>
        <p:spPr>
          <a:xfrm>
            <a:off x="252611" y="317026"/>
            <a:ext cx="1795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EBCA7BB1-6018-4EC0-94AD-CD21220DAD86}"/>
              </a:ext>
            </a:extLst>
          </p:cNvPr>
          <p:cNvSpPr txBox="1"/>
          <p:nvPr/>
        </p:nvSpPr>
        <p:spPr>
          <a:xfrm>
            <a:off x="4468836" y="316401"/>
            <a:ext cx="1469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7827B94D-DD1B-4F86-9F09-6FF6DDBC0EB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66331482"/>
              </p:ext>
            </p:extLst>
          </p:nvPr>
        </p:nvGraphicFramePr>
        <p:xfrm>
          <a:off x="636068" y="6393835"/>
          <a:ext cx="2755591" cy="362330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24" name="Prism 8" r:id="rId3" imgW="2181702" imgH="2869347" progId="Prism8.Document">
                  <p:embed/>
                </p:oleObj>
              </mc:Choice>
              <mc:Fallback>
                <p:oleObj name="Prism 8" r:id="rId3" imgW="2181702" imgH="2869347" progId="Prism8.Document">
                  <p:embed/>
                  <p:pic>
                    <p:nvPicPr>
                      <p:cNvPr id="164" name="Object 163">
                        <a:extLst>
                          <a:ext uri="{FF2B5EF4-FFF2-40B4-BE49-F238E27FC236}">
                            <a16:creationId xmlns:a16="http://schemas.microsoft.com/office/drawing/2014/main" id="{61C9C200-3924-4501-9AD3-49A32F966E0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36068" y="6393835"/>
                        <a:ext cx="2755591" cy="362330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A3557C4E-841D-4FA4-8872-F58B4D00CE0B}"/>
              </a:ext>
            </a:extLst>
          </p:cNvPr>
          <p:cNvSpPr txBox="1"/>
          <p:nvPr/>
        </p:nvSpPr>
        <p:spPr>
          <a:xfrm>
            <a:off x="270263" y="3639053"/>
            <a:ext cx="145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88FEEB5-2EE3-4CB5-AA7B-68B958902D17}"/>
              </a:ext>
            </a:extLst>
          </p:cNvPr>
          <p:cNvSpPr txBox="1"/>
          <p:nvPr/>
        </p:nvSpPr>
        <p:spPr>
          <a:xfrm>
            <a:off x="0" y="0"/>
            <a:ext cx="2770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</a:t>
            </a: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DEBE1895-C936-4FDA-BD26-B0AC3768F7E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11912567"/>
              </p:ext>
            </p:extLst>
          </p:nvPr>
        </p:nvGraphicFramePr>
        <p:xfrm>
          <a:off x="3421984" y="3810219"/>
          <a:ext cx="312906" cy="2241963"/>
        </p:xfrm>
        <a:graphic>
          <a:graphicData uri="http://schemas.openxmlformats.org/drawingml/2006/table">
            <a:tbl>
              <a:tblPr/>
              <a:tblGrid>
                <a:gridCol w="312906">
                  <a:extLst>
                    <a:ext uri="{9D8B030D-6E8A-4147-A177-3AD203B41FA5}">
                      <a16:colId xmlns:a16="http://schemas.microsoft.com/office/drawing/2014/main" val="1884288143"/>
                    </a:ext>
                  </a:extLst>
                </a:gridCol>
              </a:tblGrid>
              <a:tr h="339691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7102267"/>
                  </a:ext>
                </a:extLst>
              </a:tr>
              <a:tr h="339691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2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808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17510517"/>
                  </a:ext>
                </a:extLst>
              </a:tr>
              <a:tr h="339691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12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C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39716007"/>
                  </a:ext>
                </a:extLst>
              </a:tr>
              <a:tr h="339691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96836605"/>
                  </a:ext>
                </a:extLst>
              </a:tr>
              <a:tr h="339691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.12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FB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82131775"/>
                  </a:ext>
                </a:extLst>
              </a:tr>
              <a:tr h="271754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.2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7F7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37959204"/>
                  </a:ext>
                </a:extLst>
              </a:tr>
              <a:tr h="271754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.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00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07315902"/>
                  </a:ext>
                </a:extLst>
              </a:tr>
            </a:tbl>
          </a:graphicData>
        </a:graphic>
      </p:graphicFrame>
      <p:graphicFrame>
        <p:nvGraphicFramePr>
          <p:cNvPr id="12" name="Table 11">
            <a:extLst>
              <a:ext uri="{FF2B5EF4-FFF2-40B4-BE49-F238E27FC236}">
                <a16:creationId xmlns:a16="http://schemas.microsoft.com/office/drawing/2014/main" id="{BEF3A4ED-4F53-44C1-A73C-D4C1DD7D4DC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4423308"/>
              </p:ext>
            </p:extLst>
          </p:nvPr>
        </p:nvGraphicFramePr>
        <p:xfrm>
          <a:off x="723076" y="3810220"/>
          <a:ext cx="2605799" cy="1194435"/>
        </p:xfrm>
        <a:graphic>
          <a:graphicData uri="http://schemas.openxmlformats.org/drawingml/2006/table">
            <a:tbl>
              <a:tblPr/>
              <a:tblGrid>
                <a:gridCol w="169585">
                  <a:extLst>
                    <a:ext uri="{9D8B030D-6E8A-4147-A177-3AD203B41FA5}">
                      <a16:colId xmlns:a16="http://schemas.microsoft.com/office/drawing/2014/main" val="3801874503"/>
                    </a:ext>
                  </a:extLst>
                </a:gridCol>
                <a:gridCol w="156139">
                  <a:extLst>
                    <a:ext uri="{9D8B030D-6E8A-4147-A177-3AD203B41FA5}">
                      <a16:colId xmlns:a16="http://schemas.microsoft.com/office/drawing/2014/main" val="1350409801"/>
                    </a:ext>
                  </a:extLst>
                </a:gridCol>
                <a:gridCol w="325725">
                  <a:extLst>
                    <a:ext uri="{9D8B030D-6E8A-4147-A177-3AD203B41FA5}">
                      <a16:colId xmlns:a16="http://schemas.microsoft.com/office/drawing/2014/main" val="2083600304"/>
                    </a:ext>
                  </a:extLst>
                </a:gridCol>
                <a:gridCol w="325725">
                  <a:extLst>
                    <a:ext uri="{9D8B030D-6E8A-4147-A177-3AD203B41FA5}">
                      <a16:colId xmlns:a16="http://schemas.microsoft.com/office/drawing/2014/main" val="600018531"/>
                    </a:ext>
                  </a:extLst>
                </a:gridCol>
                <a:gridCol w="325725">
                  <a:extLst>
                    <a:ext uri="{9D8B030D-6E8A-4147-A177-3AD203B41FA5}">
                      <a16:colId xmlns:a16="http://schemas.microsoft.com/office/drawing/2014/main" val="3146452471"/>
                    </a:ext>
                  </a:extLst>
                </a:gridCol>
                <a:gridCol w="325725">
                  <a:extLst>
                    <a:ext uri="{9D8B030D-6E8A-4147-A177-3AD203B41FA5}">
                      <a16:colId xmlns:a16="http://schemas.microsoft.com/office/drawing/2014/main" val="3421443618"/>
                    </a:ext>
                  </a:extLst>
                </a:gridCol>
                <a:gridCol w="325725">
                  <a:extLst>
                    <a:ext uri="{9D8B030D-6E8A-4147-A177-3AD203B41FA5}">
                      <a16:colId xmlns:a16="http://schemas.microsoft.com/office/drawing/2014/main" val="2939372067"/>
                    </a:ext>
                  </a:extLst>
                </a:gridCol>
                <a:gridCol w="325725">
                  <a:extLst>
                    <a:ext uri="{9D8B030D-6E8A-4147-A177-3AD203B41FA5}">
                      <a16:colId xmlns:a16="http://schemas.microsoft.com/office/drawing/2014/main" val="2448441531"/>
                    </a:ext>
                  </a:extLst>
                </a:gridCol>
                <a:gridCol w="325725">
                  <a:extLst>
                    <a:ext uri="{9D8B030D-6E8A-4147-A177-3AD203B41FA5}">
                      <a16:colId xmlns:a16="http://schemas.microsoft.com/office/drawing/2014/main" val="1399077222"/>
                    </a:ext>
                  </a:extLst>
                </a:gridCol>
              </a:tblGrid>
              <a:tr h="159102">
                <a:tc gridSpan="2"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V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I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74945212"/>
                  </a:ext>
                </a:extLst>
              </a:tr>
              <a:tr h="125940"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8833265"/>
                  </a:ext>
                </a:extLst>
              </a:tr>
              <a:tr h="159102"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R</a:t>
                      </a:r>
                    </a:p>
                  </a:txBody>
                  <a:tcPr marL="9525" marR="9525" marT="9525" marB="0" vert="vert27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R2                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R2                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6464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656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08968569"/>
                  </a:ext>
                </a:extLst>
              </a:tr>
              <a:tr h="15910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R4                </a:t>
                      </a:r>
                      <a:endParaRPr lang="en-US" dirty="0"/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R4                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565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F7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66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DC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8F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63873536"/>
                  </a:ext>
                </a:extLst>
              </a:tr>
              <a:tr h="15910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R5                </a:t>
                      </a:r>
                      <a:endParaRPr lang="en-US" dirty="0"/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R5                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F7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808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98488530"/>
                  </a:ext>
                </a:extLst>
              </a:tr>
              <a:tr h="15910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R6                </a:t>
                      </a:r>
                      <a:endParaRPr lang="en-US" dirty="0"/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R6                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616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F0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171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1F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66533248"/>
                  </a:ext>
                </a:extLst>
              </a:tr>
              <a:tr h="15910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R7                </a:t>
                      </a:r>
                      <a:endParaRPr lang="en-US" dirty="0"/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R7                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6B6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DE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0E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B7B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CE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FD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63019786"/>
                  </a:ext>
                </a:extLst>
              </a:tr>
            </a:tbl>
          </a:graphicData>
        </a:graphic>
      </p:graphicFrame>
      <p:graphicFrame>
        <p:nvGraphicFramePr>
          <p:cNvPr id="13" name="Table 12">
            <a:extLst>
              <a:ext uri="{FF2B5EF4-FFF2-40B4-BE49-F238E27FC236}">
                <a16:creationId xmlns:a16="http://schemas.microsoft.com/office/drawing/2014/main" id="{2527CC16-E811-4D21-AB60-7691CCAF4BB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10975570"/>
              </p:ext>
            </p:extLst>
          </p:nvPr>
        </p:nvGraphicFramePr>
        <p:xfrm>
          <a:off x="721458" y="5099683"/>
          <a:ext cx="2601280" cy="952500"/>
        </p:xfrm>
        <a:graphic>
          <a:graphicData uri="http://schemas.openxmlformats.org/drawingml/2006/table">
            <a:tbl>
              <a:tblPr/>
              <a:tblGrid>
                <a:gridCol w="178276">
                  <a:extLst>
                    <a:ext uri="{9D8B030D-6E8A-4147-A177-3AD203B41FA5}">
                      <a16:colId xmlns:a16="http://schemas.microsoft.com/office/drawing/2014/main" val="1560555021"/>
                    </a:ext>
                  </a:extLst>
                </a:gridCol>
                <a:gridCol w="478465">
                  <a:extLst>
                    <a:ext uri="{9D8B030D-6E8A-4147-A177-3AD203B41FA5}">
                      <a16:colId xmlns:a16="http://schemas.microsoft.com/office/drawing/2014/main" val="3163416645"/>
                    </a:ext>
                  </a:extLst>
                </a:gridCol>
                <a:gridCol w="318739">
                  <a:extLst>
                    <a:ext uri="{9D8B030D-6E8A-4147-A177-3AD203B41FA5}">
                      <a16:colId xmlns:a16="http://schemas.microsoft.com/office/drawing/2014/main" val="102807410"/>
                    </a:ext>
                  </a:extLst>
                </a:gridCol>
                <a:gridCol w="325160">
                  <a:extLst>
                    <a:ext uri="{9D8B030D-6E8A-4147-A177-3AD203B41FA5}">
                      <a16:colId xmlns:a16="http://schemas.microsoft.com/office/drawing/2014/main" val="1688872058"/>
                    </a:ext>
                  </a:extLst>
                </a:gridCol>
                <a:gridCol w="325160">
                  <a:extLst>
                    <a:ext uri="{9D8B030D-6E8A-4147-A177-3AD203B41FA5}">
                      <a16:colId xmlns:a16="http://schemas.microsoft.com/office/drawing/2014/main" val="3209338573"/>
                    </a:ext>
                  </a:extLst>
                </a:gridCol>
                <a:gridCol w="325160">
                  <a:extLst>
                    <a:ext uri="{9D8B030D-6E8A-4147-A177-3AD203B41FA5}">
                      <a16:colId xmlns:a16="http://schemas.microsoft.com/office/drawing/2014/main" val="3546588585"/>
                    </a:ext>
                  </a:extLst>
                </a:gridCol>
                <a:gridCol w="325160">
                  <a:extLst>
                    <a:ext uri="{9D8B030D-6E8A-4147-A177-3AD203B41FA5}">
                      <a16:colId xmlns:a16="http://schemas.microsoft.com/office/drawing/2014/main" val="3242401367"/>
                    </a:ext>
                  </a:extLst>
                </a:gridCol>
                <a:gridCol w="325160">
                  <a:extLst>
                    <a:ext uri="{9D8B030D-6E8A-4147-A177-3AD203B41FA5}">
                      <a16:colId xmlns:a16="http://schemas.microsoft.com/office/drawing/2014/main" val="1924191968"/>
                    </a:ext>
                  </a:extLst>
                </a:gridCol>
              </a:tblGrid>
              <a:tr h="190500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RINC</a:t>
                      </a:r>
                    </a:p>
                  </a:txBody>
                  <a:tcPr marL="9525" marR="9525" marT="9525" marB="0" vert="vert27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RINC1            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4F4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CACA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3F3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BCB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9C9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92684365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RINC3            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F8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EFE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9F9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DFD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FD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55238359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RINC5            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EEE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363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BEB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ED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262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A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06994358"/>
                  </a:ext>
                </a:extLst>
              </a:tr>
              <a:tr h="190500">
                <a:tc gridSpan="2">
                  <a:txBody>
                    <a:bodyPr/>
                    <a:lstStyle/>
                    <a:p>
                      <a:pPr algn="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AMHD1              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494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3C3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121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393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C2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111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01978026"/>
                  </a:ext>
                </a:extLst>
              </a:tr>
              <a:tr h="190500">
                <a:tc gridSpan="2">
                  <a:txBody>
                    <a:bodyPr/>
                    <a:lstStyle/>
                    <a:p>
                      <a:pPr algn="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ST2                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BCBC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DAD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8181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BB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AEAE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38813583"/>
                  </a:ext>
                </a:extLst>
              </a:tr>
            </a:tbl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id="{FA2505C1-9376-4508-9EBB-A54FEDE24277}"/>
              </a:ext>
            </a:extLst>
          </p:cNvPr>
          <p:cNvSpPr txBox="1"/>
          <p:nvPr/>
        </p:nvSpPr>
        <p:spPr>
          <a:xfrm>
            <a:off x="331626" y="6488913"/>
            <a:ext cx="145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6C29FBA-37C8-4F86-9C89-B1EA1B3A6496}"/>
              </a:ext>
            </a:extLst>
          </p:cNvPr>
          <p:cNvSpPr txBox="1"/>
          <p:nvPr/>
        </p:nvSpPr>
        <p:spPr>
          <a:xfrm>
            <a:off x="3654662" y="6467678"/>
            <a:ext cx="145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99236C21-9E28-4920-BCCC-1C32BAB3A40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99082215"/>
              </p:ext>
            </p:extLst>
          </p:nvPr>
        </p:nvGraphicFramePr>
        <p:xfrm>
          <a:off x="3654662" y="6644931"/>
          <a:ext cx="3891005" cy="303764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25" name="Prism 8" r:id="rId5" imgW="4733984" imgH="3695901" progId="Prism8.Document">
                  <p:embed/>
                </p:oleObj>
              </mc:Choice>
              <mc:Fallback>
                <p:oleObj name="Prism 8" r:id="rId5" imgW="4733984" imgH="3695901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654662" y="6644931"/>
                        <a:ext cx="3891005" cy="303764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7628302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Picture 17" descr="A bunch of different cell phones&#10;&#10;Description automatically generated">
            <a:extLst>
              <a:ext uri="{FF2B5EF4-FFF2-40B4-BE49-F238E27FC236}">
                <a16:creationId xmlns:a16="http://schemas.microsoft.com/office/drawing/2014/main" id="{3CD486FF-B9C6-4B0B-9BED-CB01E5434A4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0225" y="333365"/>
            <a:ext cx="5405938" cy="909895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4EF26AB-058F-4C7B-A4A6-58DD1D280CF5}"/>
              </a:ext>
            </a:extLst>
          </p:cNvPr>
          <p:cNvSpPr txBox="1"/>
          <p:nvPr/>
        </p:nvSpPr>
        <p:spPr>
          <a:xfrm rot="16200000">
            <a:off x="541496" y="4875310"/>
            <a:ext cx="54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AC0D4B1-740C-4AD5-B5C1-933858BBB2B4}"/>
              </a:ext>
            </a:extLst>
          </p:cNvPr>
          <p:cNvSpPr txBox="1"/>
          <p:nvPr/>
        </p:nvSpPr>
        <p:spPr>
          <a:xfrm>
            <a:off x="3508586" y="9556081"/>
            <a:ext cx="10417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ASPASE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42EFFEA-3FCB-44EF-BEA8-E1024D1324BB}"/>
              </a:ext>
            </a:extLst>
          </p:cNvPr>
          <p:cNvSpPr txBox="1"/>
          <p:nvPr/>
        </p:nvSpPr>
        <p:spPr>
          <a:xfrm>
            <a:off x="6363117" y="2190442"/>
            <a:ext cx="8306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ASP 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70E8D3E-075D-4EE1-BDFB-264D4B878151}"/>
              </a:ext>
            </a:extLst>
          </p:cNvPr>
          <p:cNvSpPr txBox="1"/>
          <p:nvPr/>
        </p:nvSpPr>
        <p:spPr>
          <a:xfrm>
            <a:off x="6367872" y="3236536"/>
            <a:ext cx="7841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ASP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9A6F7B9-5E5E-4706-BD97-6D3431CAD06D}"/>
              </a:ext>
            </a:extLst>
          </p:cNvPr>
          <p:cNvSpPr txBox="1"/>
          <p:nvPr/>
        </p:nvSpPr>
        <p:spPr>
          <a:xfrm>
            <a:off x="6363117" y="4282422"/>
            <a:ext cx="9332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ASP3,7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A6D782F-0DB6-4F6B-B94C-73EAC385B24D}"/>
              </a:ext>
            </a:extLst>
          </p:cNvPr>
          <p:cNvSpPr txBox="1"/>
          <p:nvPr/>
        </p:nvSpPr>
        <p:spPr>
          <a:xfrm>
            <a:off x="6367872" y="5359290"/>
            <a:ext cx="7841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ASP6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208FB50-AB35-427F-B84A-5C534658BB57}"/>
              </a:ext>
            </a:extLst>
          </p:cNvPr>
          <p:cNvSpPr txBox="1"/>
          <p:nvPr/>
        </p:nvSpPr>
        <p:spPr>
          <a:xfrm>
            <a:off x="6367871" y="6475683"/>
            <a:ext cx="7841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ASP8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F959BB4-2D44-425E-9CC4-B55AB80A43DF}"/>
              </a:ext>
            </a:extLst>
          </p:cNvPr>
          <p:cNvSpPr txBox="1"/>
          <p:nvPr/>
        </p:nvSpPr>
        <p:spPr>
          <a:xfrm>
            <a:off x="6367871" y="7553423"/>
            <a:ext cx="7841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ASP9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0B0115A-31B1-4CD5-9BB5-236C4F8694D5}"/>
              </a:ext>
            </a:extLst>
          </p:cNvPr>
          <p:cNvSpPr txBox="1"/>
          <p:nvPr/>
        </p:nvSpPr>
        <p:spPr>
          <a:xfrm>
            <a:off x="6373540" y="8668944"/>
            <a:ext cx="8835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ASP10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FBFD0C69-E66F-48C9-8F03-B70E9BD6CCE1}"/>
              </a:ext>
            </a:extLst>
          </p:cNvPr>
          <p:cNvCxnSpPr/>
          <p:nvPr/>
        </p:nvCxnSpPr>
        <p:spPr>
          <a:xfrm>
            <a:off x="1891674" y="9492915"/>
            <a:ext cx="416292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A009C211-0F9F-482F-8206-1EA156FEC0E2}"/>
              </a:ext>
            </a:extLst>
          </p:cNvPr>
          <p:cNvCxnSpPr>
            <a:cxnSpLocks/>
          </p:cNvCxnSpPr>
          <p:nvPr/>
        </p:nvCxnSpPr>
        <p:spPr>
          <a:xfrm flipV="1">
            <a:off x="1044199" y="2027903"/>
            <a:ext cx="0" cy="727832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Rectangle 19">
            <a:extLst>
              <a:ext uri="{FF2B5EF4-FFF2-40B4-BE49-F238E27FC236}">
                <a16:creationId xmlns:a16="http://schemas.microsoft.com/office/drawing/2014/main" id="{AD7CEE34-F42B-49F0-9A20-88151EED519B}"/>
              </a:ext>
            </a:extLst>
          </p:cNvPr>
          <p:cNvSpPr/>
          <p:nvPr/>
        </p:nvSpPr>
        <p:spPr>
          <a:xfrm>
            <a:off x="1778974" y="1920546"/>
            <a:ext cx="309560" cy="34776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6FBD49D5-9D91-414A-8AA8-29C928E09B37}"/>
              </a:ext>
            </a:extLst>
          </p:cNvPr>
          <p:cNvSpPr/>
          <p:nvPr/>
        </p:nvSpPr>
        <p:spPr>
          <a:xfrm>
            <a:off x="2040244" y="565093"/>
            <a:ext cx="318431" cy="327368"/>
          </a:xfrm>
          <a:prstGeom prst="rect">
            <a:avLst/>
          </a:prstGeom>
          <a:noFill/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512ECA95-EF66-4B54-A116-1F4BE46149FB}"/>
              </a:ext>
            </a:extLst>
          </p:cNvPr>
          <p:cNvSpPr/>
          <p:nvPr/>
        </p:nvSpPr>
        <p:spPr>
          <a:xfrm>
            <a:off x="2884643" y="1924174"/>
            <a:ext cx="309561" cy="344133"/>
          </a:xfrm>
          <a:prstGeom prst="rect">
            <a:avLst/>
          </a:prstGeom>
          <a:noFill/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AF15511D-8BC8-421D-B011-500EE67831E0}"/>
              </a:ext>
            </a:extLst>
          </p:cNvPr>
          <p:cNvSpPr/>
          <p:nvPr/>
        </p:nvSpPr>
        <p:spPr>
          <a:xfrm>
            <a:off x="2923652" y="3005873"/>
            <a:ext cx="325499" cy="329880"/>
          </a:xfrm>
          <a:prstGeom prst="rect">
            <a:avLst/>
          </a:prstGeom>
          <a:noFill/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D6BFCC5F-A717-4244-9522-B94A3CE9C491}"/>
              </a:ext>
            </a:extLst>
          </p:cNvPr>
          <p:cNvSpPr/>
          <p:nvPr/>
        </p:nvSpPr>
        <p:spPr>
          <a:xfrm>
            <a:off x="2784807" y="4130135"/>
            <a:ext cx="409396" cy="255799"/>
          </a:xfrm>
          <a:prstGeom prst="rect">
            <a:avLst/>
          </a:prstGeom>
          <a:noFill/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90737D24-EFCE-4D9A-9E03-2700342AFD94}"/>
              </a:ext>
            </a:extLst>
          </p:cNvPr>
          <p:cNvSpPr/>
          <p:nvPr/>
        </p:nvSpPr>
        <p:spPr>
          <a:xfrm>
            <a:off x="3007094" y="5167497"/>
            <a:ext cx="287117" cy="309462"/>
          </a:xfrm>
          <a:prstGeom prst="rect">
            <a:avLst/>
          </a:prstGeom>
          <a:noFill/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AA624FBC-6451-4B84-ADE1-0F5C59DC59E8}"/>
              </a:ext>
            </a:extLst>
          </p:cNvPr>
          <p:cNvSpPr/>
          <p:nvPr/>
        </p:nvSpPr>
        <p:spPr>
          <a:xfrm>
            <a:off x="2883235" y="6258522"/>
            <a:ext cx="347675" cy="290512"/>
          </a:xfrm>
          <a:prstGeom prst="rect">
            <a:avLst/>
          </a:prstGeom>
          <a:noFill/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BED1BB42-A2A9-4CF1-B465-DA76E308E7A3}"/>
              </a:ext>
            </a:extLst>
          </p:cNvPr>
          <p:cNvSpPr/>
          <p:nvPr/>
        </p:nvSpPr>
        <p:spPr>
          <a:xfrm>
            <a:off x="2812837" y="7353205"/>
            <a:ext cx="377434" cy="290512"/>
          </a:xfrm>
          <a:prstGeom prst="rect">
            <a:avLst/>
          </a:prstGeom>
          <a:noFill/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82FCF49C-ADD0-4F73-97E4-398819789272}"/>
              </a:ext>
            </a:extLst>
          </p:cNvPr>
          <p:cNvSpPr/>
          <p:nvPr/>
        </p:nvSpPr>
        <p:spPr>
          <a:xfrm>
            <a:off x="2918405" y="8428296"/>
            <a:ext cx="344094" cy="317760"/>
          </a:xfrm>
          <a:prstGeom prst="rect">
            <a:avLst/>
          </a:prstGeom>
          <a:noFill/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B0CFEDA0-F948-41A4-AAB9-145B0B8E5371}"/>
              </a:ext>
            </a:extLst>
          </p:cNvPr>
          <p:cNvSpPr/>
          <p:nvPr/>
        </p:nvSpPr>
        <p:spPr>
          <a:xfrm>
            <a:off x="1823764" y="3012340"/>
            <a:ext cx="325498" cy="32736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483A8CCD-ACA1-40BB-A412-AA5F8DD3A534}"/>
              </a:ext>
            </a:extLst>
          </p:cNvPr>
          <p:cNvSpPr/>
          <p:nvPr/>
        </p:nvSpPr>
        <p:spPr>
          <a:xfrm>
            <a:off x="1680415" y="4130755"/>
            <a:ext cx="405351" cy="25517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20AE8203-6FD6-487C-B3A4-3838568262E8}"/>
              </a:ext>
            </a:extLst>
          </p:cNvPr>
          <p:cNvSpPr/>
          <p:nvPr/>
        </p:nvSpPr>
        <p:spPr>
          <a:xfrm>
            <a:off x="1905022" y="5167497"/>
            <a:ext cx="287116" cy="30946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FCFB5A7C-B481-40C8-8CD0-6A6884BA23C2}"/>
              </a:ext>
            </a:extLst>
          </p:cNvPr>
          <p:cNvSpPr/>
          <p:nvPr/>
        </p:nvSpPr>
        <p:spPr>
          <a:xfrm>
            <a:off x="1783564" y="6253143"/>
            <a:ext cx="347665" cy="29051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4962F588-16D0-4492-B293-E4903F3D2A48}"/>
              </a:ext>
            </a:extLst>
          </p:cNvPr>
          <p:cNvSpPr/>
          <p:nvPr/>
        </p:nvSpPr>
        <p:spPr>
          <a:xfrm>
            <a:off x="1706343" y="7356734"/>
            <a:ext cx="377434" cy="29051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32524B23-58BB-4498-9519-4F4E6B217DD5}"/>
              </a:ext>
            </a:extLst>
          </p:cNvPr>
          <p:cNvSpPr/>
          <p:nvPr/>
        </p:nvSpPr>
        <p:spPr>
          <a:xfrm>
            <a:off x="1804846" y="8428296"/>
            <a:ext cx="344094" cy="3177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7D08D32D-62D6-4642-8E1A-12F4F4F74135}"/>
              </a:ext>
            </a:extLst>
          </p:cNvPr>
          <p:cNvSpPr txBox="1"/>
          <p:nvPr/>
        </p:nvSpPr>
        <p:spPr>
          <a:xfrm>
            <a:off x="513571" y="141228"/>
            <a:ext cx="145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33B94DD-883E-4F24-940C-2CC330645061}"/>
              </a:ext>
            </a:extLst>
          </p:cNvPr>
          <p:cNvSpPr txBox="1"/>
          <p:nvPr/>
        </p:nvSpPr>
        <p:spPr>
          <a:xfrm>
            <a:off x="1975182" y="240131"/>
            <a:ext cx="6463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C6B500FF-257D-447C-B8A3-52EF9295AC6D}"/>
              </a:ext>
            </a:extLst>
          </p:cNvPr>
          <p:cNvSpPr txBox="1"/>
          <p:nvPr/>
        </p:nvSpPr>
        <p:spPr>
          <a:xfrm>
            <a:off x="3911992" y="239122"/>
            <a:ext cx="9028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QVD-OPH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9A3B94B4-C35D-41E8-8A4E-792CCAF9EEAC}"/>
              </a:ext>
            </a:extLst>
          </p:cNvPr>
          <p:cNvSpPr txBox="1"/>
          <p:nvPr/>
        </p:nvSpPr>
        <p:spPr>
          <a:xfrm>
            <a:off x="5383362" y="233561"/>
            <a:ext cx="9797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Uninfected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57F0E4FD-0929-4E00-82C2-3A46BD3C83AF}"/>
              </a:ext>
            </a:extLst>
          </p:cNvPr>
          <p:cNvSpPr/>
          <p:nvPr/>
        </p:nvSpPr>
        <p:spPr>
          <a:xfrm>
            <a:off x="2367577" y="563849"/>
            <a:ext cx="338328" cy="32861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84548647-BCE1-4A05-A805-2A3317D1875E}"/>
              </a:ext>
            </a:extLst>
          </p:cNvPr>
          <p:cNvSpPr txBox="1"/>
          <p:nvPr/>
        </p:nvSpPr>
        <p:spPr>
          <a:xfrm>
            <a:off x="1545637" y="1611160"/>
            <a:ext cx="4716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24+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C7FEDF76-E731-47D6-8612-9438199668C4}"/>
              </a:ext>
            </a:extLst>
          </p:cNvPr>
          <p:cNvSpPr txBox="1"/>
          <p:nvPr/>
        </p:nvSpPr>
        <p:spPr>
          <a:xfrm>
            <a:off x="2647433" y="1611159"/>
            <a:ext cx="4539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24-</a:t>
            </a:r>
          </a:p>
        </p:txBody>
      </p:sp>
    </p:spTree>
    <p:extLst>
      <p:ext uri="{BB962C8B-B14F-4D97-AF65-F5344CB8AC3E}">
        <p14:creationId xmlns:p14="http://schemas.microsoft.com/office/powerpoint/2010/main" val="4996459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506</TotalTime>
  <Words>503</Words>
  <Application>Microsoft Office PowerPoint</Application>
  <PresentationFormat>Custom</PresentationFormat>
  <Paragraphs>487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rism 8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gura, Jason (NIH/NIAID) [F]</dc:creator>
  <cp:lastModifiedBy>Sun, Peter (NIH/NIAID) [E]</cp:lastModifiedBy>
  <cp:revision>1890</cp:revision>
  <cp:lastPrinted>2022-11-29T16:07:58Z</cp:lastPrinted>
  <dcterms:created xsi:type="dcterms:W3CDTF">2018-11-20T18:59:25Z</dcterms:created>
  <dcterms:modified xsi:type="dcterms:W3CDTF">2023-01-20T15:59:52Z</dcterms:modified>
</cp:coreProperties>
</file>